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178E9A-CACD-45EF-81B1-3AE010CDBB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A1DB3-32DC-4671-BC59-9B460E2829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5AEBE-4183-47A5-A9E2-0DFD2753A6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B3CCE-4B63-4EC6-ACA4-72BE7223A9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357AA-7DD6-44A4-8F45-78A036910F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B3DAD-2ECB-47B5-85C1-E5CCB260CF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4B6D2-13D6-47A8-8B34-E46E14025E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D63033-09D1-4735-88A6-7F02050460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ADB15A-486D-442A-945C-E1445CB7C1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619E7D-90D4-4B39-972E-30648E311D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BC7B98-075B-420D-8153-80B4CBED60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2C75C6-B965-4F51-9F8C-B6D12ECB34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237CAE-07A7-4D1B-BDE0-8D610CBA840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8" descr="http://genome.ucsc.edu/trash/hgt/hgt_genome_4547_76fd80.png"/>
          <p:cNvPicPr/>
          <p:nvPr/>
        </p:nvPicPr>
        <p:blipFill>
          <a:blip r:embed="rId1"/>
          <a:srcRect l="6180" t="0" r="12734" b="0"/>
          <a:stretch/>
        </p:blipFill>
        <p:spPr>
          <a:xfrm>
            <a:off x="838080" y="1066680"/>
            <a:ext cx="8153640" cy="1143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68360" y="181296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CpG 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33520" y="2971800"/>
            <a:ext cx="83977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1600" spc="-1" strike="noStrike">
                <a:solidFill>
                  <a:srgbClr val="000000"/>
                </a:solidFill>
                <a:latin typeface="Arial"/>
              </a:rPr>
              <a:t>Figure S2.</a:t>
            </a:r>
            <a:r>
              <a:rPr b="0" lang="fr-CA" sz="1600" spc="-1" strike="noStrike">
                <a:solidFill>
                  <a:srgbClr val="000000"/>
                </a:solidFill>
                <a:latin typeface="Arial"/>
              </a:rPr>
              <a:t> Genomic structure of the RUNX2 gene, isoforms a, b and c. The CpG island (CpG 60) containing the analyzed 12 putative CpG methylation targets is indicated with arrow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flipV="1">
            <a:off x="1676520" y="213336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42800" y="1066680"/>
            <a:ext cx="279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252080" y="14479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07T21:57:17Z</dcterms:created>
  <dc:creator>dbatch</dc:creator>
  <dc:description/>
  <dc:language>en-US</dc:language>
  <cp:lastModifiedBy>Dbatch</cp:lastModifiedBy>
  <dcterms:modified xsi:type="dcterms:W3CDTF">2013-09-10T16:28:34Z</dcterms:modified>
  <cp:revision>6</cp:revision>
  <dc:subject/>
  <dc:title>Diapositive 1</dc:title>
</cp:coreProperties>
</file>